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25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ocument\&#20010;&#20154;&#25991;&#20214;\2018.12\manuscript\Table%20S1%20Gene%20expression%20profiles%20of%206%20Villus%20and%20decidua%20derived%20by%20this%20study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/>
      <c:barChart>
        <c:barDir val="col"/>
        <c:grouping val="clustered"/>
        <c:ser>
          <c:idx val="0"/>
          <c:order val="0"/>
          <c:tx>
            <c:strRef>
              <c:f>Sheet1!$A$10</c:f>
              <c:strCache>
                <c:ptCount val="1"/>
                <c:pt idx="0">
                  <c:v>DDX3Y</c:v>
                </c:pt>
              </c:strCache>
            </c:strRef>
          </c:tx>
          <c:cat>
            <c:strRef>
              <c:f>Sheet1!$B$9:$G$9</c:f>
              <c:strCache>
                <c:ptCount val="6"/>
                <c:pt idx="0">
                  <c:v>10_4</c:v>
                </c:pt>
                <c:pt idx="1">
                  <c:v>11_1</c:v>
                </c:pt>
                <c:pt idx="2">
                  <c:v>12_2</c:v>
                </c:pt>
                <c:pt idx="3">
                  <c:v>13_4</c:v>
                </c:pt>
                <c:pt idx="4">
                  <c:v>9_4</c:v>
                </c:pt>
                <c:pt idx="5">
                  <c:v>8_4</c:v>
                </c:pt>
              </c:strCache>
            </c:strRef>
          </c:cat>
          <c:val>
            <c:numRef>
              <c:f>Sheet1!$B$10:$G$10</c:f>
              <c:numCache>
                <c:formatCode>General</c:formatCode>
                <c:ptCount val="6"/>
                <c:pt idx="0">
                  <c:v>3109</c:v>
                </c:pt>
                <c:pt idx="1">
                  <c:v>2841</c:v>
                </c:pt>
                <c:pt idx="2">
                  <c:v>3195</c:v>
                </c:pt>
                <c:pt idx="3">
                  <c:v>5</c:v>
                </c:pt>
                <c:pt idx="4">
                  <c:v>5</c:v>
                </c:pt>
                <c:pt idx="5">
                  <c:v>2970</c:v>
                </c:pt>
              </c:numCache>
            </c:numRef>
          </c:val>
        </c:ser>
        <c:ser>
          <c:idx val="1"/>
          <c:order val="1"/>
          <c:tx>
            <c:strRef>
              <c:f>Sheet1!$A$11</c:f>
              <c:strCache>
                <c:ptCount val="1"/>
                <c:pt idx="0">
                  <c:v>EIF1AY</c:v>
                </c:pt>
              </c:strCache>
            </c:strRef>
          </c:tx>
          <c:cat>
            <c:strRef>
              <c:f>Sheet1!$B$9:$G$9</c:f>
              <c:strCache>
                <c:ptCount val="6"/>
                <c:pt idx="0">
                  <c:v>10_4</c:v>
                </c:pt>
                <c:pt idx="1">
                  <c:v>11_1</c:v>
                </c:pt>
                <c:pt idx="2">
                  <c:v>12_2</c:v>
                </c:pt>
                <c:pt idx="3">
                  <c:v>13_4</c:v>
                </c:pt>
                <c:pt idx="4">
                  <c:v>9_4</c:v>
                </c:pt>
                <c:pt idx="5">
                  <c:v>8_4</c:v>
                </c:pt>
              </c:strCache>
            </c:strRef>
          </c:cat>
          <c:val>
            <c:numRef>
              <c:f>Sheet1!$B$11:$G$11</c:f>
              <c:numCache>
                <c:formatCode>General</c:formatCode>
                <c:ptCount val="6"/>
                <c:pt idx="0">
                  <c:v>534</c:v>
                </c:pt>
                <c:pt idx="1">
                  <c:v>378</c:v>
                </c:pt>
                <c:pt idx="2">
                  <c:v>357</c:v>
                </c:pt>
                <c:pt idx="3">
                  <c:v>3</c:v>
                </c:pt>
                <c:pt idx="4">
                  <c:v>13</c:v>
                </c:pt>
                <c:pt idx="5">
                  <c:v>488</c:v>
                </c:pt>
              </c:numCache>
            </c:numRef>
          </c:val>
        </c:ser>
        <c:ser>
          <c:idx val="2"/>
          <c:order val="2"/>
          <c:tx>
            <c:strRef>
              <c:f>Sheet1!$A$12</c:f>
              <c:strCache>
                <c:ptCount val="1"/>
                <c:pt idx="0">
                  <c:v>KDM5D</c:v>
                </c:pt>
              </c:strCache>
            </c:strRef>
          </c:tx>
          <c:cat>
            <c:strRef>
              <c:f>Sheet1!$B$9:$G$9</c:f>
              <c:strCache>
                <c:ptCount val="6"/>
                <c:pt idx="0">
                  <c:v>10_4</c:v>
                </c:pt>
                <c:pt idx="1">
                  <c:v>11_1</c:v>
                </c:pt>
                <c:pt idx="2">
                  <c:v>12_2</c:v>
                </c:pt>
                <c:pt idx="3">
                  <c:v>13_4</c:v>
                </c:pt>
                <c:pt idx="4">
                  <c:v>9_4</c:v>
                </c:pt>
                <c:pt idx="5">
                  <c:v>8_4</c:v>
                </c:pt>
              </c:strCache>
            </c:strRef>
          </c:cat>
          <c:val>
            <c:numRef>
              <c:f>Sheet1!$B$12:$G$12</c:f>
              <c:numCache>
                <c:formatCode>General</c:formatCode>
                <c:ptCount val="6"/>
                <c:pt idx="0">
                  <c:v>988</c:v>
                </c:pt>
                <c:pt idx="1">
                  <c:v>878</c:v>
                </c:pt>
                <c:pt idx="2">
                  <c:v>723</c:v>
                </c:pt>
                <c:pt idx="3">
                  <c:v>4</c:v>
                </c:pt>
                <c:pt idx="4">
                  <c:v>13</c:v>
                </c:pt>
                <c:pt idx="5">
                  <c:v>771</c:v>
                </c:pt>
              </c:numCache>
            </c:numRef>
          </c:val>
        </c:ser>
        <c:ser>
          <c:idx val="3"/>
          <c:order val="3"/>
          <c:tx>
            <c:strRef>
              <c:f>Sheet1!$A$13</c:f>
              <c:strCache>
                <c:ptCount val="1"/>
                <c:pt idx="0">
                  <c:v>RPS4Y1</c:v>
                </c:pt>
              </c:strCache>
            </c:strRef>
          </c:tx>
          <c:cat>
            <c:strRef>
              <c:f>Sheet1!$B$9:$G$9</c:f>
              <c:strCache>
                <c:ptCount val="6"/>
                <c:pt idx="0">
                  <c:v>10_4</c:v>
                </c:pt>
                <c:pt idx="1">
                  <c:v>11_1</c:v>
                </c:pt>
                <c:pt idx="2">
                  <c:v>12_2</c:v>
                </c:pt>
                <c:pt idx="3">
                  <c:v>13_4</c:v>
                </c:pt>
                <c:pt idx="4">
                  <c:v>9_4</c:v>
                </c:pt>
                <c:pt idx="5">
                  <c:v>8_4</c:v>
                </c:pt>
              </c:strCache>
            </c:strRef>
          </c:cat>
          <c:val>
            <c:numRef>
              <c:f>Sheet1!$B$13:$G$13</c:f>
              <c:numCache>
                <c:formatCode>General</c:formatCode>
                <c:ptCount val="6"/>
                <c:pt idx="0">
                  <c:v>3210</c:v>
                </c:pt>
                <c:pt idx="1">
                  <c:v>2374</c:v>
                </c:pt>
                <c:pt idx="2">
                  <c:v>2465</c:v>
                </c:pt>
                <c:pt idx="3">
                  <c:v>3</c:v>
                </c:pt>
                <c:pt idx="4">
                  <c:v>3</c:v>
                </c:pt>
                <c:pt idx="5">
                  <c:v>5081</c:v>
                </c:pt>
              </c:numCache>
            </c:numRef>
          </c:val>
        </c:ser>
        <c:axId val="210649088"/>
        <c:axId val="210652544"/>
      </c:barChart>
      <c:catAx>
        <c:axId val="210649088"/>
        <c:scaling>
          <c:orientation val="minMax"/>
        </c:scaling>
        <c:axPos val="b"/>
        <c:tickLblPos val="nextTo"/>
        <c:crossAx val="210652544"/>
        <c:crosses val="autoZero"/>
        <c:auto val="1"/>
        <c:lblAlgn val="ctr"/>
        <c:lblOffset val="100"/>
      </c:catAx>
      <c:valAx>
        <c:axId val="21065254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sz="1000" b="1" i="0" u="none" strike="noStrike" baseline="0"/>
                  <a:t>CPM</a:t>
                </a:r>
                <a:endParaRPr lang="zh-CN" altLang="en-US"/>
              </a:p>
            </c:rich>
          </c:tx>
          <c:layout/>
        </c:title>
        <c:numFmt formatCode="General" sourceLinked="1"/>
        <c:tickLblPos val="nextTo"/>
        <c:crossAx val="210649088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434487-D183-4EC0-8435-25476A446B2B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FA1021-2C73-4091-8CD2-24AD00802B3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D9574E-4D1C-428F-A548-1B9F75516110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843991"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D9574E-4D1C-428F-A548-1B9F75516110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D9574E-4D1C-428F-A548-1B9F75516110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CBE4FB-E57C-4899-A746-027847200F85}" type="datetimeFigureOut">
              <a:rPr lang="zh-CN" altLang="en-US" smtClean="0"/>
              <a:pPr/>
              <a:t>2020/7/6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A49A4-DAAF-466B-814F-89AC8264332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48680" y="1475656"/>
            <a:ext cx="5805264" cy="2847602"/>
            <a:chOff x="504056" y="395536"/>
            <a:chExt cx="5805264" cy="2847602"/>
          </a:xfrm>
        </p:grpSpPr>
        <p:grpSp>
          <p:nvGrpSpPr>
            <p:cNvPr id="3" name="组合 47"/>
            <p:cNvGrpSpPr>
              <a:grpSpLocks/>
            </p:cNvGrpSpPr>
            <p:nvPr/>
          </p:nvGrpSpPr>
          <p:grpSpPr bwMode="auto">
            <a:xfrm>
              <a:off x="504056" y="395536"/>
              <a:ext cx="3809629" cy="2845577"/>
              <a:chOff x="1236663" y="404813"/>
              <a:chExt cx="6430962" cy="4841875"/>
            </a:xfrm>
          </p:grpSpPr>
          <p:pic>
            <p:nvPicPr>
              <p:cNvPr id="6" name="Picture 2" descr="D:\document\2018.12\manuscript\微信图片_20190109221845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476750" y="2852738"/>
                <a:ext cx="3190875" cy="2393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" name="Picture 3" descr="D:\document\2018.12\manuscript\微信图片_20190109221857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236663" y="2852738"/>
                <a:ext cx="3190875" cy="2393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" name="Picture 4" descr="D:\document\2018.12\manuscript\微信图片_20190109221728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476750" y="404813"/>
                <a:ext cx="3190875" cy="2393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" name="Picture 5" descr="D:\document\2018.12\manuscript\微信图片_20190109221833.jp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236663" y="404813"/>
                <a:ext cx="3190875" cy="2393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4" name="Picture 2" descr="D:\document\个人文件\2018.12\manuscript\微信图片_20190717142003.jpg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472353" y="1795034"/>
              <a:ext cx="1834941" cy="1448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3" descr="D:\document\个人文件\2018.12\manuscript\微信图片_20190717142032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472353" y="395536"/>
              <a:ext cx="1836967" cy="13772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10" name="组合 9"/>
          <p:cNvGrpSpPr/>
          <p:nvPr/>
        </p:nvGrpSpPr>
        <p:grpSpPr>
          <a:xfrm>
            <a:off x="188640" y="4932040"/>
            <a:ext cx="6628635" cy="2370299"/>
            <a:chOff x="467544" y="332656"/>
            <a:chExt cx="7519312" cy="2688791"/>
          </a:xfrm>
        </p:grpSpPr>
        <p:pic>
          <p:nvPicPr>
            <p:cNvPr id="11" name="Picture 10" descr="D:\document\个人文件\2020.4\20200416 荧光 张怡4张拍照 郑州王宾伟 5115945\20200416 荧光 张怡4张拍照 郑州王宾伟 5115945\绒毛 KRTT-7红 200-1.jpg"/>
            <p:cNvPicPr>
              <a:picLocks noChangeAspect="1" noChangeArrowheads="1"/>
            </p:cNvPicPr>
            <p:nvPr/>
          </p:nvPicPr>
          <p:blipFill>
            <a:blip r:embed="rId9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467544" y="332656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2" name="Picture 11" descr="D:\document\个人文件\2020.4\20200416 荧光 张怡4张拍照 郑州王宾伟 5115945\20200416 荧光 张怡4张拍照 郑州王宾伟 5115945\绒毛 KRTT-7红 200-2.jpg"/>
            <p:cNvPicPr>
              <a:picLocks noChangeAspect="1" noChangeArrowheads="1"/>
            </p:cNvPicPr>
            <p:nvPr/>
          </p:nvPicPr>
          <p:blipFill>
            <a:blip r:embed="rId10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4211960" y="332656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3" name="Picture 12" descr="D:\document\个人文件\2020.4\20200416 荧光 张怡4张拍照 郑州王宾伟 5115945\20200416 荧光 张怡4张拍照 郑州王宾伟 5115945\绒毛 TEAD1红+TEAD3绿 200-1 2 3.jpg"/>
            <p:cNvPicPr>
              <a:picLocks noChangeAspect="1" noChangeArrowheads="1"/>
            </p:cNvPicPr>
            <p:nvPr/>
          </p:nvPicPr>
          <p:blipFill>
            <a:blip r:embed="rId11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6099227" y="1697642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4" name="Picture 13" descr="D:\document\个人文件\2020.4\20200416 荧光 张怡4张拍照 郑州王宾伟 5115945\20200416 荧光 张怡4张拍照 郑州王宾伟 5115945\绒毛 TEAD1红+TEAD3绿 200-1.jpg"/>
            <p:cNvPicPr>
              <a:picLocks noChangeAspect="1" noChangeArrowheads="1"/>
            </p:cNvPicPr>
            <p:nvPr/>
          </p:nvPicPr>
          <p:blipFill>
            <a:blip r:embed="rId12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467544" y="1697642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5" name="Picture 14" descr="D:\document\个人文件\2020.4\20200416 荧光 张怡4张拍照 郑州王宾伟 5115945\20200416 荧光 张怡4张拍照 郑州王宾伟 5115945\绒毛 TEAD1红+TEAD3绿 200-2.jpg"/>
            <p:cNvPicPr>
              <a:picLocks noChangeAspect="1" noChangeArrowheads="1"/>
            </p:cNvPicPr>
            <p:nvPr/>
          </p:nvPicPr>
          <p:blipFill>
            <a:blip r:embed="rId13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2339752" y="1700808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6" name="Picture 15" descr="D:\document\个人文件\2020.4\20200416 荧光 张怡4张拍照 郑州王宾伟 5115945\20200416 荧光 张怡4张拍照 郑州王宾伟 5115945\绒毛 TEAD1红+TEAD3绿 200-3.jpg"/>
            <p:cNvPicPr>
              <a:picLocks noChangeAspect="1" noChangeArrowheads="1"/>
            </p:cNvPicPr>
            <p:nvPr/>
          </p:nvPicPr>
          <p:blipFill>
            <a:blip r:embed="rId14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4211960" y="1697642"/>
              <a:ext cx="1857149" cy="1320639"/>
            </a:xfrm>
            <a:prstGeom prst="rect">
              <a:avLst/>
            </a:prstGeom>
            <a:noFill/>
          </p:spPr>
        </p:pic>
        <p:pic>
          <p:nvPicPr>
            <p:cNvPr id="17" name="Picture 16" descr="D:\document\个人文件\2020.4\20200416 荧光 张怡4张拍照 郑州王宾伟 5115945\20200416 荧光 张怡4张拍照 郑州王宾伟 5115945\绒毛 KRTT-7红 200-1 2.jpg"/>
            <p:cNvPicPr>
              <a:picLocks noChangeAspect="1" noChangeArrowheads="1"/>
            </p:cNvPicPr>
            <p:nvPr/>
          </p:nvPicPr>
          <p:blipFill>
            <a:blip r:embed="rId15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6099227" y="332656"/>
              <a:ext cx="1857149" cy="1320639"/>
            </a:xfrm>
            <a:prstGeom prst="rect">
              <a:avLst/>
            </a:prstGeom>
            <a:noFill/>
          </p:spPr>
        </p:pic>
        <p:sp>
          <p:nvSpPr>
            <p:cNvPr id="18" name="矩形 17"/>
            <p:cNvSpPr/>
            <p:nvPr/>
          </p:nvSpPr>
          <p:spPr>
            <a:xfrm>
              <a:off x="5450854" y="1331476"/>
              <a:ext cx="621091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DAPI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5436097" y="2636912"/>
              <a:ext cx="621091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DAPI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1691680" y="1268760"/>
              <a:ext cx="636657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KRT7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1547664" y="2636912"/>
              <a:ext cx="763435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TEAD4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3347865" y="2636912"/>
              <a:ext cx="738632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HLA-G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>
              <a:off x="7231626" y="1331476"/>
              <a:ext cx="750561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Merge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7236295" y="2636912"/>
              <a:ext cx="750561" cy="3491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>
                  <a:solidFill>
                    <a:schemeClr val="bg1"/>
                  </a:solidFill>
                </a:rPr>
                <a:t>Merge</a:t>
              </a:r>
              <a:endParaRPr lang="zh-CN" altLang="en-US" sz="14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25" name="矩形 24"/>
          <p:cNvSpPr>
            <a:spLocks noChangeArrowheads="1"/>
          </p:cNvSpPr>
          <p:nvPr/>
        </p:nvSpPr>
        <p:spPr bwMode="auto">
          <a:xfrm>
            <a:off x="188640" y="1187624"/>
            <a:ext cx="2778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矩形 25"/>
          <p:cNvSpPr>
            <a:spLocks noChangeArrowheads="1"/>
          </p:cNvSpPr>
          <p:nvPr/>
        </p:nvSpPr>
        <p:spPr bwMode="auto">
          <a:xfrm>
            <a:off x="188640" y="4572000"/>
            <a:ext cx="2778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1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 cstate="print"/>
          <a:stretch/>
        </p:blipFill>
        <p:spPr>
          <a:xfrm>
            <a:off x="0" y="0"/>
            <a:ext cx="6896336" cy="8834825"/>
          </a:xfrm>
          <a:prstGeom prst="rect">
            <a:avLst/>
          </a:prstGeom>
          <a:ln>
            <a:noFill/>
          </a:ln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83708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10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1484784" y="1619672"/>
          <a:ext cx="4147200" cy="3317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2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矩形 34"/>
          <p:cNvSpPr>
            <a:spLocks noChangeArrowheads="1"/>
          </p:cNvSpPr>
          <p:nvPr/>
        </p:nvSpPr>
        <p:spPr bwMode="auto">
          <a:xfrm>
            <a:off x="1110112" y="1478295"/>
            <a:ext cx="24826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5" name="组合 12"/>
          <p:cNvGrpSpPr>
            <a:grpSpLocks/>
          </p:cNvGrpSpPr>
          <p:nvPr/>
        </p:nvGrpSpPr>
        <p:grpSpPr bwMode="auto">
          <a:xfrm>
            <a:off x="332656" y="5580112"/>
            <a:ext cx="6525344" cy="2456338"/>
            <a:chOff x="233361" y="690286"/>
            <a:chExt cx="9203963" cy="3465789"/>
          </a:xfrm>
        </p:grpSpPr>
        <p:grpSp>
          <p:nvGrpSpPr>
            <p:cNvPr id="6" name="组合 7"/>
            <p:cNvGrpSpPr>
              <a:grpSpLocks/>
            </p:cNvGrpSpPr>
            <p:nvPr/>
          </p:nvGrpSpPr>
          <p:grpSpPr bwMode="auto">
            <a:xfrm>
              <a:off x="233361" y="690286"/>
              <a:ext cx="9062090" cy="1478239"/>
              <a:chOff x="1878843" y="1288310"/>
              <a:chExt cx="9990978" cy="1629815"/>
            </a:xfrm>
          </p:grpSpPr>
          <p:grpSp>
            <p:nvGrpSpPr>
              <p:cNvPr id="7" name="组合 1"/>
              <p:cNvGrpSpPr>
                <a:grpSpLocks/>
              </p:cNvGrpSpPr>
              <p:nvPr/>
            </p:nvGrpSpPr>
            <p:grpSpPr bwMode="auto">
              <a:xfrm>
                <a:off x="1878843" y="1331563"/>
                <a:ext cx="9990978" cy="1586562"/>
                <a:chOff x="190555" y="1308161"/>
                <a:chExt cx="12230249" cy="961777"/>
              </a:xfrm>
            </p:grpSpPr>
            <p:pic>
              <p:nvPicPr>
                <p:cNvPr id="14" name="图片 40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6834" t="6467" r="1161" b="4999"/>
                <a:stretch>
                  <a:fillRect/>
                </a:stretch>
              </p:blipFill>
              <p:spPr bwMode="auto">
                <a:xfrm>
                  <a:off x="879496" y="1308161"/>
                  <a:ext cx="11384502" cy="67678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5" name="图片 2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t="94727" r="1161" b="632"/>
                <a:stretch>
                  <a:fillRect/>
                </a:stretch>
              </p:blipFill>
              <p:spPr bwMode="auto">
                <a:xfrm>
                  <a:off x="190555" y="1984987"/>
                  <a:ext cx="12230249" cy="28495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13" name="矩形 6"/>
              <p:cNvSpPr>
                <a:spLocks noChangeArrowheads="1"/>
              </p:cNvSpPr>
              <p:nvPr/>
            </p:nvSpPr>
            <p:spPr bwMode="auto">
              <a:xfrm>
                <a:off x="1978865" y="1288310"/>
                <a:ext cx="641187" cy="12927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8_4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9_4 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0_4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1_1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2_2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3_4</a:t>
                </a:r>
              </a:p>
            </p:txBody>
          </p:sp>
        </p:grpSp>
        <p:grpSp>
          <p:nvGrpSpPr>
            <p:cNvPr id="8" name="组合 9"/>
            <p:cNvGrpSpPr>
              <a:grpSpLocks/>
            </p:cNvGrpSpPr>
            <p:nvPr/>
          </p:nvGrpSpPr>
          <p:grpSpPr bwMode="auto">
            <a:xfrm>
              <a:off x="296303" y="2353692"/>
              <a:ext cx="9141021" cy="1802383"/>
              <a:chOff x="181815" y="3889962"/>
              <a:chExt cx="10078558" cy="1987619"/>
            </a:xfrm>
          </p:grpSpPr>
          <p:grpSp>
            <p:nvGrpSpPr>
              <p:cNvPr id="12" name="组合 3"/>
              <p:cNvGrpSpPr>
                <a:grpSpLocks/>
              </p:cNvGrpSpPr>
              <p:nvPr/>
            </p:nvGrpSpPr>
            <p:grpSpPr bwMode="auto">
              <a:xfrm>
                <a:off x="359794" y="3947662"/>
                <a:ext cx="9900579" cy="1929919"/>
                <a:chOff x="30962" y="5652216"/>
                <a:chExt cx="12373906" cy="1241815"/>
              </a:xfrm>
            </p:grpSpPr>
            <p:pic>
              <p:nvPicPr>
                <p:cNvPr id="10" name="图片 4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4462" t="6970" b="8653"/>
                <a:stretch>
                  <a:fillRect/>
                </a:stretch>
              </p:blipFill>
              <p:spPr bwMode="auto">
                <a:xfrm>
                  <a:off x="480634" y="5652216"/>
                  <a:ext cx="11821881" cy="71940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1" name="图片 5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t="91734"/>
                <a:stretch>
                  <a:fillRect/>
                </a:stretch>
              </p:blipFill>
              <p:spPr bwMode="auto">
                <a:xfrm>
                  <a:off x="30962" y="6378242"/>
                  <a:ext cx="12373906" cy="51578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9" name="矩形 8"/>
              <p:cNvSpPr>
                <a:spLocks noChangeArrowheads="1"/>
              </p:cNvSpPr>
              <p:nvPr/>
            </p:nvSpPr>
            <p:spPr bwMode="auto">
              <a:xfrm>
                <a:off x="181815" y="3889962"/>
                <a:ext cx="679420" cy="12930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8_4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9_4 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0_4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1_1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2_2</a:t>
                </a:r>
              </a:p>
              <a:p>
                <a:r>
                  <a:rPr lang="en-US" altLang="zh-CN" sz="800" b="1" dirty="0">
                    <a:solidFill>
                      <a:srgbClr val="000000"/>
                    </a:solidFill>
                  </a:rPr>
                  <a:t>13_4</a:t>
                </a:r>
              </a:p>
            </p:txBody>
          </p:sp>
        </p:grpSp>
      </p:grpSp>
      <p:sp>
        <p:nvSpPr>
          <p:cNvPr id="16" name="矩形 34"/>
          <p:cNvSpPr>
            <a:spLocks noChangeArrowheads="1"/>
          </p:cNvSpPr>
          <p:nvPr/>
        </p:nvSpPr>
        <p:spPr bwMode="auto">
          <a:xfrm>
            <a:off x="116632" y="5292082"/>
            <a:ext cx="24826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istrator\Downloads\newplot(1)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5250" y="2428875"/>
            <a:ext cx="6667500" cy="4286250"/>
          </a:xfrm>
          <a:prstGeom prst="rect">
            <a:avLst/>
          </a:prstGeom>
          <a:noFill/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3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document\个人文件\2018.12\manuscript\Supplementary file\gProfiler_hsapiens_2020-07-03_04-55-52.png"/>
          <p:cNvPicPr>
            <a:picLocks noChangeAspect="1" noChangeArrowheads="1"/>
          </p:cNvPicPr>
          <p:nvPr/>
        </p:nvPicPr>
        <p:blipFill>
          <a:blip r:embed="rId2" cstate="print"/>
          <a:srcRect b="10145"/>
          <a:stretch>
            <a:fillRect/>
          </a:stretch>
        </p:blipFill>
        <p:spPr bwMode="auto">
          <a:xfrm>
            <a:off x="0" y="971600"/>
            <a:ext cx="6858000" cy="5832648"/>
          </a:xfrm>
          <a:prstGeom prst="rect">
            <a:avLst/>
          </a:prstGeom>
          <a:noFill/>
        </p:spPr>
      </p:pic>
      <p:sp>
        <p:nvSpPr>
          <p:cNvPr id="4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4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D:\document\个人文件\2018.12\manuscript\Supplementary file\gProfiler_hsapiens_2020-07-03_05-48-57.png"/>
          <p:cNvPicPr>
            <a:picLocks noChangeAspect="1" noChangeArrowheads="1"/>
          </p:cNvPicPr>
          <p:nvPr/>
        </p:nvPicPr>
        <p:blipFill>
          <a:blip r:embed="rId2" cstate="print"/>
          <a:srcRect b="11060"/>
          <a:stretch>
            <a:fillRect/>
          </a:stretch>
        </p:blipFill>
        <p:spPr bwMode="auto">
          <a:xfrm>
            <a:off x="0" y="1115616"/>
            <a:ext cx="6858000" cy="5472608"/>
          </a:xfrm>
          <a:prstGeom prst="rect">
            <a:avLst/>
          </a:prstGeom>
          <a:noFill/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5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3" cstate="print"/>
          <a:stretch/>
        </p:blipFill>
        <p:spPr>
          <a:xfrm>
            <a:off x="548680" y="1403648"/>
            <a:ext cx="5670000" cy="5670360"/>
          </a:xfrm>
          <a:prstGeom prst="rect">
            <a:avLst/>
          </a:prstGeom>
          <a:ln>
            <a:noFill/>
          </a:ln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6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/>
          <p:nvPr/>
        </p:nvPicPr>
        <p:blipFill>
          <a:blip r:embed="rId2" cstate="print"/>
          <a:stretch/>
        </p:blipFill>
        <p:spPr>
          <a:xfrm>
            <a:off x="476672" y="1475656"/>
            <a:ext cx="5913680" cy="5309600"/>
          </a:xfrm>
          <a:prstGeom prst="rect">
            <a:avLst/>
          </a:prstGeom>
          <a:ln>
            <a:noFill/>
          </a:ln>
        </p:spPr>
      </p:pic>
      <p:sp>
        <p:nvSpPr>
          <p:cNvPr id="4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7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2" cstate="print"/>
          <a:stretch/>
        </p:blipFill>
        <p:spPr>
          <a:xfrm>
            <a:off x="0" y="2051720"/>
            <a:ext cx="6858000" cy="5190027"/>
          </a:xfrm>
          <a:prstGeom prst="rect">
            <a:avLst/>
          </a:prstGeom>
          <a:ln>
            <a:noFill/>
          </a:ln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8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 cstate="print"/>
          <a:stretch/>
        </p:blipFill>
        <p:spPr>
          <a:xfrm>
            <a:off x="0" y="611560"/>
            <a:ext cx="6848130" cy="6192688"/>
          </a:xfrm>
          <a:prstGeom prst="rect">
            <a:avLst/>
          </a:prstGeom>
          <a:ln>
            <a:noFill/>
          </a:ln>
        </p:spPr>
      </p:pic>
      <p:sp>
        <p:nvSpPr>
          <p:cNvPr id="3" name="矩形 34"/>
          <p:cNvSpPr>
            <a:spLocks noChangeArrowheads="1"/>
          </p:cNvSpPr>
          <p:nvPr/>
        </p:nvSpPr>
        <p:spPr bwMode="auto">
          <a:xfrm>
            <a:off x="3" y="2"/>
            <a:ext cx="7665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9</a:t>
            </a:r>
            <a:endParaRPr lang="en-US" altLang="zh-CN" sz="10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</Words>
  <Application>Microsoft Office PowerPoint</Application>
  <PresentationFormat>全屏显示(4:3)</PresentationFormat>
  <Paragraphs>37</Paragraphs>
  <Slides>10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1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</vt:vector>
  </TitlesOfParts>
  <Company>CHIN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u Yajun</dc:creator>
  <cp:lastModifiedBy>Liu Yajun</cp:lastModifiedBy>
  <cp:revision>2</cp:revision>
  <dcterms:created xsi:type="dcterms:W3CDTF">2020-07-05T19:09:26Z</dcterms:created>
  <dcterms:modified xsi:type="dcterms:W3CDTF">2020-07-05T20:26:56Z</dcterms:modified>
</cp:coreProperties>
</file>